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92C3FBF8-D0E1-45F3-94C0-2734360A8452}"/>
              </a:ext>
            </a:extLst>
          </p:cNvPr>
          <p:cNvSpPr/>
          <p:nvPr/>
        </p:nvSpPr>
        <p:spPr>
          <a:xfrm>
            <a:off x="250783" y="160064"/>
            <a:ext cx="1127228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 within cross-sectional and longitudinal study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891 individuals from 19 studies. The squares indicate individual study SMD and their corresponding 95% CIs and the sizes of the squares are proportional to study weight. AD, Alzheimer’s disease. HC, healthy controls. CSF, cerebrospinal fluid. SMD, standard mean difference. CI, confidence interval.</a:t>
            </a:r>
            <a:endParaRPr lang="zh-CN" altLang="zh-CN" sz="11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D081A338-0791-40A5-A1D5-1A83A89B444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27" b="3443"/>
          <a:stretch/>
        </p:blipFill>
        <p:spPr>
          <a:xfrm>
            <a:off x="2759184" y="1118152"/>
            <a:ext cx="6673633" cy="56752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0978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3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7</cp:revision>
  <dcterms:created xsi:type="dcterms:W3CDTF">2019-09-16T04:07:01Z</dcterms:created>
  <dcterms:modified xsi:type="dcterms:W3CDTF">2020-03-12T01:20:27Z</dcterms:modified>
</cp:coreProperties>
</file>